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83" r:id="rId2"/>
    <p:sldId id="284" r:id="rId3"/>
    <p:sldId id="268" r:id="rId4"/>
    <p:sldId id="280" r:id="rId5"/>
    <p:sldId id="275" r:id="rId6"/>
    <p:sldId id="281" r:id="rId7"/>
    <p:sldId id="267" r:id="rId8"/>
    <p:sldId id="269" r:id="rId9"/>
    <p:sldId id="27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>
      <p:cViewPr>
        <p:scale>
          <a:sx n="80" d="100"/>
          <a:sy n="80" d="100"/>
        </p:scale>
        <p:origin x="691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2A5EAE-E89A-40C0-A027-04424607612A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65B031-32B0-43C0-9F88-C651987364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007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92EDD2-0C40-4477-9A0B-2E67086E4F5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5937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92EDD2-0C40-4477-9A0B-2E67086E4F5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038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730BC-4B92-446D-BF9B-F3D0DF183E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88004A-D4A7-4B5E-A446-05E310F5E4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176C70-3EEA-455A-868E-7A7D3836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1659AF-95F6-415C-A71A-895E279CA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4C773-223A-4BF3-B7BD-94D122DE4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01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D0FC0-6DBD-43E3-AFC6-9D1B2DC076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D2F8E1-3215-4BF7-8B02-89C1D6087F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339951-88D7-47A6-B0E2-F70D965D6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9127D-631D-420E-8875-4328E8EE1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F6DFA-49CF-4AB1-8BEC-C386DF832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1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4426DC-70E1-4FC8-88C0-ADEBCC72B4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026DC6-0D6B-4BD9-AB46-DFA5E66AF7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EB627D-04E5-4B46-92BD-982A6CC2D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B228D-A3CF-4ED0-8755-9C0710F4C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3A1C00-FF46-48DD-A05C-381224C75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772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619B8-1D6A-4DA3-BE85-DE2D236AE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3FEAF8-8005-494B-82F4-F0C8D3B211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B6A5E8-12AA-4FE0-9523-DE8E531BA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F7C5F-0C21-451F-AEF0-269FA06EE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6CF47-3AF5-433D-BB3E-6CC8ED2BE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82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BAA5C-86D3-4D3A-9C96-C4C8CCC72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E0891F-58CC-42CF-9319-75B6C02FF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7785C-629F-4E03-B072-CB5D5764B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23EFC1-88D9-4430-B738-C965F309F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6B3B53-5A12-4305-BD6C-82997EA90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462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5173A-7641-452C-A63C-9784B3E2A3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361806-3D9E-49A4-93EE-113DDDD431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FC8FDF-56A5-4639-88E2-1203913C7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640CCA-BE14-41ED-8968-7A074B559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83A22C-699A-4318-BD5D-9D8248DCA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5D0386-6782-43FB-A9E7-D72CA60C7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284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64E01-67C4-4C72-83A4-C97705F84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C4EC84-6DD7-4E63-B5DB-70F9713DC9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AD17D0-702A-4512-B6B0-FB2C7AA91E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F34F57-06AC-4148-9EB1-E4B3006F30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E9B190-057E-44CD-8FF5-56538FA44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592091-CF88-4FF8-8E6A-65B7C4172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0B816D-1347-4BAB-910E-CF943CC15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55E604-F27E-4056-8FFB-1B1308470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211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1128E-D39E-4153-87FE-B4669880F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B78919-E8DC-4B6A-B020-CF0DD0970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98F41A-16CE-4AE0-824A-747CF9D70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5844B1-A090-40B3-A425-B0BD08E6A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420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4F6829-BBE0-4038-8DA0-128006634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416EA3-2B38-4F20-8C04-FFE3A526C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DA3D5A-4DBA-465B-A896-35AA9218C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328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02414-8D5F-4D3B-9606-90CEA69AEB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AA3F05-8D05-4BA2-9751-25797C5F94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90B4B8-2052-4D44-82A7-73B54F3EBA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ABC6C8-F47C-4114-9058-9635F3F63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2467D0-6298-4B02-B5DE-2A5E0B3DE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3A6309-4931-4E30-A894-FF50458C9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462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53E706-1BF7-445A-92B9-55B5DE8F0B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F288B9-BEAB-44E7-AA3D-F708A4C6A1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BEC98D-A332-4FE1-AA9E-71D33B677D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1DBD1-B223-41E9-94F2-BB3B07778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D00EA0-A954-4594-AD5B-67C86392B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23D22D-FA7C-41E6-B45E-BB063F530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78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9F0D86-3814-4EC2-A95B-0AA61A882E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11D638-602F-4D0E-833C-71E883736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358F7-B2A3-4BB6-A6F0-6EAD9AE6F7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FBA3B-68A2-4086-8129-C737D170D52D}" type="datetimeFigureOut">
              <a:rPr lang="en-US" smtClean="0"/>
              <a:t>5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66F750-2E7B-4999-84E9-45BA180A2C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1CB2AF-288C-4B30-AF98-48DEC49A8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C9CEF-7C48-4A31-AF07-553665AE3E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70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4B76EAA4-3750-49E7-98FB-F18D07040F52}"/>
              </a:ext>
            </a:extLst>
          </p:cNvPr>
          <p:cNvSpPr txBox="1"/>
          <p:nvPr/>
        </p:nvSpPr>
        <p:spPr>
          <a:xfrm>
            <a:off x="0" y="5892675"/>
            <a:ext cx="1002811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upplemental Figure 1. Gating strategy for Treg identification. Supplemental Figure 1. Gating strategy for Treg identification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Lymphocytes were gated based on size (FSC) and granularity (SSC)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Single cells were gated based on FSC-height and FSC-area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Dead cells were excluded using Live/Dead dye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.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 cells were identified by CD3 and CD4 expression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Negative control for Foxp3 and CD25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 Tregs were identified based on the positive expression of Foxp3 and CD25. </a:t>
            </a:r>
            <a:endParaRPr lang="en-US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5A7A31-CC06-4E38-B7CF-1FDBE574CB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956" y="0"/>
            <a:ext cx="8255960" cy="5748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02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1F882D8-DFBA-4D39-B74D-83C2F758B162}"/>
              </a:ext>
            </a:extLst>
          </p:cNvPr>
          <p:cNvSpPr txBox="1"/>
          <p:nvPr/>
        </p:nvSpPr>
        <p:spPr>
          <a:xfrm>
            <a:off x="0" y="4588468"/>
            <a:ext cx="11887200" cy="22695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2. Helios and CD127 expression on miTregs. 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MAPC induction of Tregs at day 4 (black), day 5 (blue) or day 7 (yellow) post-co-culture. Data represent mean ± SD from pooled samples of 2 independent experiments. Statistical analysis was performed by a Two-way ANOVA with a Sidak’s Multiple Comparisons test (****p&lt;0.0001, ***p&lt;0.001). Quantification of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Treg cell counts per well and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Ki67 expression on Tregs at day 5 (blue) and day 7 (yellow) in PBMCs cultured alone or with MAPC cell at 2:1 and 4:1 PBMC: MAPC cell ratios. Data represent mean ± SEM from pooled samples of 3 independent experiments. Statistical analysis was performed by a Two-way ANOVA with a Sidak’s Multiple Comparisons test (****p&lt;0.0001, ***p&lt;0.001).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Representative histogram depicting Helios expression on Tregs from PBMC (black line), 2:1 (blue line), and 4:1 (red line) PBMC: MAPC 7-day co-cultures. FMO showed as dotted line. Graph showing quantification of Helios expression on Tregs. Data represent mean ± SD from pooled samples of 3 independent experiments.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Representative dot plot depicting Treg frequencies in cultures of PBMCS, 2:1 and 4:1 PBMC: MAPC co-cultures, cells were gated based on CD127</a:t>
            </a:r>
            <a:r>
              <a:rPr lang="en-US" sz="9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ow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25</a:t>
            </a:r>
            <a:r>
              <a:rPr lang="en-US" sz="9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</a:t>
            </a:r>
            <a:r>
              <a:rPr lang="en-US" sz="9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.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Representative density plot depicting Treg proliferation measured by dilution of cell proliferation dye in PBMCs alone, 2:1, and 4:1 PBMC: MAPC cell ratios. Graph shows quantification of Treg proliferation.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L-2 levels in supernatants from PBMCs cultured alone or with MAPC cells at 2:1 and 4:1 PBMC: MAPC cell ratios measured by ELISA. Quantification of intracellular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L-2 and (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TGFβ on Tregs. Data represent mean ± SD from pooled samples of 3 independent experiments with 3 different PBMC donors. Statistical analysis was performed using One-way ANOVA with a Tukey’s multiple comparisons test reference to the PBMC alone (****p&lt;0.0001, ** p&lt;0.01, and *p&lt;0.05)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E0AB3B02-4419-485B-9173-2C04A29E67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817" y="87498"/>
            <a:ext cx="8088198" cy="4705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4275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6783719-C05C-45E8-BDE5-9AC9A3FC9CAB}"/>
              </a:ext>
            </a:extLst>
          </p:cNvPr>
          <p:cNvSpPr txBox="1"/>
          <p:nvPr/>
        </p:nvSpPr>
        <p:spPr>
          <a:xfrm>
            <a:off x="-1" y="4886631"/>
            <a:ext cx="11892683" cy="23192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3. Co-cultures of CD25 depleted PBMCs with MAPC increase Treg frequencies. 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Representative dot plots of Tregs frequencies from unfractionated PBMCs and CD25-depleted PBMCs. 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Treg frequencies in 7-day co-cultures of CD25 depleted PBMCs alone (black), or with MAPC at 2:1 (blue) or 4:1 (red) CD25 depleted PBMC: MAPC ratios. Quantification of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Ki67 and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HLA-DR expression on Tregs.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the frequencies of CD45RA</a:t>
            </a:r>
            <a:r>
              <a:rPr lang="en-US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5RO</a:t>
            </a:r>
            <a:r>
              <a:rPr lang="en-US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egs. Data represent mean ± SD from pooled samples of 3 independent experiments with 3 different PBMC donors. Statistical analysis was performed using One-way ANOVA with a Tukey’s multiple comparisons test reference to the control CD25</a:t>
            </a:r>
            <a:r>
              <a:rPr lang="en-US" sz="105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BMC alone (****p&lt;0.0001, *** p&lt;0.001, and **p&lt;0.01).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Treg induction by MAPC cells at 2:1 and 4:1 PBMC: MAPC cell ratios cultured in direct contact (black circles) or in </a:t>
            </a:r>
            <a:r>
              <a:rPr lang="en-US" sz="105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well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gray squares). Data represented as mean ± SD from polled samples of 3 independent experiments with 3 different PBMC donors. Statistical analysis was performed using Two-way ANOVA with Tukey’s multiple comparisons test.</a:t>
            </a:r>
            <a:endParaRPr lang="en-US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endParaRPr lang="en-US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Chart, diagram&#10;&#10;Description automatically generated">
            <a:extLst>
              <a:ext uri="{FF2B5EF4-FFF2-40B4-BE49-F238E27FC236}">
                <a16:creationId xmlns:a16="http://schemas.microsoft.com/office/drawing/2014/main" id="{35F80B5A-B443-40AA-9E9F-A8DF57A5DE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9886951" cy="5001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35533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D777DC78-2158-40EB-89FD-89DAB5A14D3C}"/>
              </a:ext>
            </a:extLst>
          </p:cNvPr>
          <p:cNvSpPr txBox="1"/>
          <p:nvPr/>
        </p:nvSpPr>
        <p:spPr>
          <a:xfrm>
            <a:off x="882940" y="3793231"/>
            <a:ext cx="9443907" cy="15179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4. MAPC cells do not induce CTLA-4, HLA-DR and PD-L1 expression on FoxP3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Quantification of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CTLA-4,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HLA-DR, and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PD-L1 expression on FoxP3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. Data represented as mean ± SEM from pooled samples of 4 independent experiments with 4 different PBMC donors. Statistical analysis was performed using One-way ANOVA with a Tukey’s multiple comparisons test referenced to control PBMC alon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7B9E31-1246-486D-AE63-5241A89B0C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685" y="708388"/>
            <a:ext cx="10510415" cy="30848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24985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BD3B8DEE-714B-4A38-9F67-F6CF1E8E3866}"/>
              </a:ext>
            </a:extLst>
          </p:cNvPr>
          <p:cNvSpPr txBox="1"/>
          <p:nvPr/>
        </p:nvSpPr>
        <p:spPr>
          <a:xfrm>
            <a:off x="7483796" y="299931"/>
            <a:ext cx="4245255" cy="63192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5. MAPC induced CD45RA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5RO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ansitional Tregs arise from CD45RA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egs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Graph showing quantification of Treg percentages in co-cultures of enriched CD45RA (black) or CD45RO (gray)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and CD1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ocytes (2:1, CD4: monocytes) alone and with MAPC (2:1:1, CD4: Monocyte: MAPC). Quantification of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Ki67 and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HLA-DR expression on Tregs from co-cultures of enriched CD45RA (black) or CD45RO (gray)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and CD1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ocytes (2:1, CD4: monocytes) alone and with MAPC (2:1:1, CD4: Monocyte: MAPC).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CD45RA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5RO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ansitional Tregs from co-cultures of enriched CD45RA (black) or CD45RO (blue)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and CD1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ocytes (2:1, CD4: monocytes) alone and with MAPC (2:1:1, CD4: Monocyte: MAPC). Data represent mean ± SD from pooled samples of 2 independent experiments with 2 different PBMC donors. Statistical analysis was performed using One-way ANOVA with a Sidak’s multiple comparisons test (****p&lt;0.0001 and *p&lt;0.05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FE1F29E-1CFB-49BD-8428-7348F23887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7362958" cy="6619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13393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6D36E11-2034-4B25-B808-9198CE0AAEFA}"/>
              </a:ext>
            </a:extLst>
          </p:cNvPr>
          <p:cNvSpPr txBox="1"/>
          <p:nvPr/>
        </p:nvSpPr>
        <p:spPr>
          <a:xfrm>
            <a:off x="1082953" y="2820329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98013F-6CA3-436C-947B-A906EE1514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154" y="0"/>
            <a:ext cx="3790950" cy="27813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EF29F9A-6CA6-47D8-B117-CE544F19D972}"/>
              </a:ext>
            </a:extLst>
          </p:cNvPr>
          <p:cNvSpPr txBox="1"/>
          <p:nvPr/>
        </p:nvSpPr>
        <p:spPr>
          <a:xfrm>
            <a:off x="119543" y="3668340"/>
            <a:ext cx="6094602" cy="2256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6. Increased HLA-DR expression on FoxP3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D4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after TGFβ inhibition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ph showing quantification of HLA-DR expression on effector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from PBMCs cultured with vehicle (DMSO, black) or SB 431542 (TGF</a:t>
            </a:r>
            <a:r>
              <a:rPr lang="el-GR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1 inhibitor, grey, 10µΜ). Data represent mean ± SD from pooled samples of 3 independent experiments with 3 different PBMC donors. Statistical analysis was performed using unpaired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-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sts with Welch’s correction (***p=0.0002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05478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B606298C-141B-4877-BAA7-E77C134DE377}"/>
              </a:ext>
            </a:extLst>
          </p:cNvPr>
          <p:cNvSpPr txBox="1"/>
          <p:nvPr/>
        </p:nvSpPr>
        <p:spPr>
          <a:xfrm>
            <a:off x="9530597" y="5910"/>
            <a:ext cx="2586548" cy="68335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7.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hibition of IDO partially reduces MAPC cell mediated induction of Tregs. 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ntracellular IDO in MAPC cells cultured alone (gold) or with PBMCs at 2:1 PBMC: MAPC cell ratio (blue). Graph depicting quantification of IDO MFI in MAPC cells cultured alone or with PBMCS at 2:1 PBMC: MAPC cell ratio.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Quantification of Treg percentages after 7-day co-culture with MAPC cells in the presence of vehicle (DMSO, black) or INCB024360 (IDO inhibitor, grey, 10</a:t>
            </a:r>
            <a:r>
              <a:rPr lang="el-GR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). Graphs showing quantification of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Ki67,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TLA-4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LA-DR, and (</a:t>
            </a:r>
            <a:r>
              <a:rPr lang="en-US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</a:t>
            </a:r>
            <a:r>
              <a:rPr lang="en-US" sz="105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PD-L1 expression on Tregs. Data represent mean ± SD from pooled samples of 5 independent experiments. Statistical analysis was performed using Two-way ANOVA with Sidak’s multiple comparison test (****p&lt;0.0001) *** p&lt;0.001, **p&lt;0.01, and * p&lt;0.05).</a:t>
            </a:r>
            <a:endParaRPr lang="en-US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3730ED9-3E46-43A1-A81F-604E3AC28B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8553"/>
            <a:ext cx="967138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9343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5C7795D6-6540-4272-9297-26708A99EEB6}"/>
              </a:ext>
            </a:extLst>
          </p:cNvPr>
          <p:cNvSpPr txBox="1"/>
          <p:nvPr/>
        </p:nvSpPr>
        <p:spPr>
          <a:xfrm>
            <a:off x="1014928" y="3981123"/>
            <a:ext cx="6094602" cy="2256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8. Depletion of CD14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ocytes does not affect TGF</a:t>
            </a:r>
            <a:r>
              <a:rPr lang="el-GR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evels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TGFβ and (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LAP levels in supernatants collected from PBMCs (black) or CD14 depleted PBMCs (gray) cultured alone or with MAPC at 2:1 and 4:1 PBMC: MAPC ratios for 7 days measured by ELISA. Data represent mean ± SD from pooled samples of multiple independent experiments. Statistical analysis was performed using One-way ANOVA with a Sidak’s multiple comparisons test between unfractionated and CD14 depleted PBMCs (****p&lt;0.0001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13EDAFD-5588-452D-887C-3A42A95C50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604" y="219565"/>
            <a:ext cx="7565792" cy="3761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75148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70A48C14-B481-49FF-9FF5-59BCD974AAAA}"/>
              </a:ext>
            </a:extLst>
          </p:cNvPr>
          <p:cNvGrpSpPr/>
          <p:nvPr/>
        </p:nvGrpSpPr>
        <p:grpSpPr>
          <a:xfrm>
            <a:off x="0" y="5072"/>
            <a:ext cx="6605858" cy="5669341"/>
            <a:chOff x="0" y="5072"/>
            <a:chExt cx="6605858" cy="5669341"/>
          </a:xfrm>
        </p:grpSpPr>
        <p:pic>
          <p:nvPicPr>
            <p:cNvPr id="7" name="Picture 6" descr="Diagram, schematic&#10;&#10;Description automatically generated">
              <a:extLst>
                <a:ext uri="{FF2B5EF4-FFF2-40B4-BE49-F238E27FC236}">
                  <a16:creationId xmlns:a16="http://schemas.microsoft.com/office/drawing/2014/main" id="{8EB07FD6-5B34-405D-99F8-B4D9B9EB26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072"/>
              <a:ext cx="6605858" cy="5669341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ED66BB3-ADB7-4487-97C6-A2658D7EFB4F}"/>
                </a:ext>
              </a:extLst>
            </p:cNvPr>
            <p:cNvSpPr txBox="1"/>
            <p:nvPr/>
          </p:nvSpPr>
          <p:spPr>
            <a:xfrm>
              <a:off x="4042911" y="5305081"/>
              <a:ext cx="23193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plemental Figure 9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20F354D8-776B-4C32-AB63-55B5C7C79047}"/>
              </a:ext>
            </a:extLst>
          </p:cNvPr>
          <p:cNvSpPr txBox="1"/>
          <p:nvPr/>
        </p:nvSpPr>
        <p:spPr>
          <a:xfrm>
            <a:off x="7029973" y="2604954"/>
            <a:ext cx="4888685" cy="2256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9. MAPC cell induction of Tregs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eractions between MAPC cells and Tregs promote Treg expansion and enhance Treg suppressive function characterized by increased expression of CTLA-4, HLA-DR, and PD-L1. Additionally, MAPC cells drive the conversion of CD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 cells into Tregs via secretion of TGFβ and IDO, as well as interactions with CD14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onocytes, which in turn secrete IL-10. Created using Biorender.co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8078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456</Words>
  <Application>Microsoft Office PowerPoint</Application>
  <PresentationFormat>Widescreen</PresentationFormat>
  <Paragraphs>13</Paragraphs>
  <Slides>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ce Valentin-Torres</dc:creator>
  <cp:lastModifiedBy>Alice Valentin-Torres</cp:lastModifiedBy>
  <cp:revision>4</cp:revision>
  <dcterms:created xsi:type="dcterms:W3CDTF">2021-04-05T20:59:02Z</dcterms:created>
  <dcterms:modified xsi:type="dcterms:W3CDTF">2021-05-16T05:47:28Z</dcterms:modified>
</cp:coreProperties>
</file>